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  <p15:guide id="3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1315" y="-91"/>
      </p:cViewPr>
      <p:guideLst>
        <p:guide orient="horz" pos="2160"/>
        <p:guide pos="288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52869-31E7-478C-9315-C98BCA5F9E75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F13FD3-BABA-4AB8-BC8B-CDF78C431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52869-31E7-478C-9315-C98BCA5F9E75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F13FD3-BABA-4AB8-BC8B-CDF78C431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81850" y="274639"/>
            <a:ext cx="222885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5300" y="274639"/>
            <a:ext cx="652145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52869-31E7-478C-9315-C98BCA5F9E75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F13FD3-BABA-4AB8-BC8B-CDF78C431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52869-31E7-478C-9315-C98BCA5F9E75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F13FD3-BABA-4AB8-BC8B-CDF78C431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52869-31E7-478C-9315-C98BCA5F9E75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F13FD3-BABA-4AB8-BC8B-CDF78C431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530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555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52869-31E7-478C-9315-C98BCA5F9E75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F13FD3-BABA-4AB8-BC8B-CDF78C431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52869-31E7-478C-9315-C98BCA5F9E75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F13FD3-BABA-4AB8-BC8B-CDF78C431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52869-31E7-478C-9315-C98BCA5F9E75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F13FD3-BABA-4AB8-BC8B-CDF78C431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52869-31E7-478C-9315-C98BCA5F9E75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F13FD3-BABA-4AB8-BC8B-CDF78C431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52869-31E7-478C-9315-C98BCA5F9E75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F13FD3-BABA-4AB8-BC8B-CDF78C431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52869-31E7-478C-9315-C98BCA5F9E75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F13FD3-BABA-4AB8-BC8B-CDF78C431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A52869-31E7-478C-9315-C98BCA5F9E75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F13FD3-BABA-4AB8-BC8B-CDF78C431B2B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76200" y="286138"/>
            <a:ext cx="4399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(A)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3A3C9B55-22BA-4FC9-9078-373E2E535A6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12037"/>
          <a:stretch/>
        </p:blipFill>
        <p:spPr>
          <a:xfrm>
            <a:off x="2768280" y="699297"/>
            <a:ext cx="2041358" cy="2274826"/>
          </a:xfrm>
          <a:prstGeom prst="rect">
            <a:avLst/>
          </a:prstGeom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xmlns="" id="{9CD71F18-279C-49D8-B437-A7A66307D7BC}"/>
              </a:ext>
            </a:extLst>
          </p:cNvPr>
          <p:cNvSpPr/>
          <p:nvPr/>
        </p:nvSpPr>
        <p:spPr>
          <a:xfrm>
            <a:off x="76200" y="805041"/>
            <a:ext cx="2788464" cy="20928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ponse to wounding</a:t>
            </a:r>
          </a:p>
          <a:p>
            <a:pPr algn="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P synthesis coupled electron transport</a:t>
            </a:r>
          </a:p>
          <a:p>
            <a:pPr algn="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yptophanyl-tRNA aminoacylation</a:t>
            </a:r>
          </a:p>
          <a:p>
            <a:pPr algn="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ycerol ether metabolic process</a:t>
            </a:r>
          </a:p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KC activating GPCR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naling pathway</a:t>
            </a:r>
          </a:p>
          <a:p>
            <a:pPr algn="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outer membrane</a:t>
            </a:r>
          </a:p>
          <a:p>
            <a:pPr algn="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rine-type endopeptidase inhibitor activity</a:t>
            </a:r>
          </a:p>
          <a:p>
            <a:pPr algn="r"/>
            <a:r>
              <a:rPr lang="en-US" altLang="zh-CN" sz="1000" dirty="0">
                <a:latin typeface="Times New Roman" pitchFamily="18" charset="0"/>
                <a:cs typeface="Times New Roman" pitchFamily="18" charset="0"/>
              </a:rPr>
              <a:t>EC:2.7.6.3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vity</a:t>
            </a:r>
          </a:p>
          <a:p>
            <a:pPr algn="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lyribonucleotide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ucleotidyltransferase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tivity</a:t>
            </a:r>
          </a:p>
          <a:p>
            <a:pPr algn="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yptophan-tRNA ligase activity</a:t>
            </a:r>
          </a:p>
          <a:p>
            <a:pPr algn="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inoacyl-tRNA editing activity</a:t>
            </a:r>
          </a:p>
          <a:p>
            <a:pPr algn="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rbohydrate binding</a:t>
            </a:r>
          </a:p>
          <a:p>
            <a:pPr algn="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acylglycerol kinase activity</a:t>
            </a: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xmlns="" id="{ED1982D8-5518-47FA-BA54-A73D4DECC4C7}"/>
              </a:ext>
            </a:extLst>
          </p:cNvPr>
          <p:cNvSpPr txBox="1"/>
          <p:nvPr/>
        </p:nvSpPr>
        <p:spPr>
          <a:xfrm>
            <a:off x="2768280" y="286138"/>
            <a:ext cx="19078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 of Proteins (%)</a:t>
            </a: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xmlns="" id="{4873A55D-5E2C-4721-B1E3-ACAEAC88C459}"/>
              </a:ext>
            </a:extLst>
          </p:cNvPr>
          <p:cNvSpPr txBox="1"/>
          <p:nvPr/>
        </p:nvSpPr>
        <p:spPr>
          <a:xfrm>
            <a:off x="2694992" y="523935"/>
            <a:ext cx="21146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                                           10</a:t>
            </a: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xmlns="" id="{C4132476-38B4-403C-AE7B-A0F2ACFD97B9}"/>
              </a:ext>
            </a:extLst>
          </p:cNvPr>
          <p:cNvSpPr txBox="1"/>
          <p:nvPr/>
        </p:nvSpPr>
        <p:spPr>
          <a:xfrm>
            <a:off x="2740287" y="2923593"/>
            <a:ext cx="21644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                                         5.7</a:t>
            </a: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xmlns="" id="{FA74417F-C024-4811-A049-07EC6363F12C}"/>
              </a:ext>
            </a:extLst>
          </p:cNvPr>
          <p:cNvSpPr txBox="1"/>
          <p:nvPr/>
        </p:nvSpPr>
        <p:spPr>
          <a:xfrm>
            <a:off x="2981166" y="3062092"/>
            <a:ext cx="16155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proteins</a:t>
            </a:r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xmlns="" id="{2E370921-F6CC-4E70-8AEF-BEE910C1A40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39884"/>
          <a:stretch/>
        </p:blipFill>
        <p:spPr>
          <a:xfrm>
            <a:off x="7594729" y="691289"/>
            <a:ext cx="2082671" cy="4566511"/>
          </a:xfrm>
          <a:prstGeom prst="rect">
            <a:avLst/>
          </a:prstGeom>
        </p:spPr>
      </p:pic>
      <p:sp>
        <p:nvSpPr>
          <p:cNvPr id="16" name="矩形 15">
            <a:extLst>
              <a:ext uri="{FF2B5EF4-FFF2-40B4-BE49-F238E27FC236}">
                <a16:creationId xmlns:a16="http://schemas.microsoft.com/office/drawing/2014/main" xmlns="" id="{B291FC76-F1E3-4984-AA35-BDA123F91455}"/>
              </a:ext>
            </a:extLst>
          </p:cNvPr>
          <p:cNvSpPr/>
          <p:nvPr/>
        </p:nvSpPr>
        <p:spPr>
          <a:xfrm>
            <a:off x="4904752" y="898655"/>
            <a:ext cx="2867647" cy="424853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>
              <a:lnSpc>
                <a:spcPts val="9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wall organization or biogenesis</a:t>
            </a:r>
          </a:p>
          <a:p>
            <a:pPr algn="r">
              <a:lnSpc>
                <a:spcPts val="9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ycolipid transport</a:t>
            </a:r>
          </a:p>
          <a:p>
            <a:pPr algn="r">
              <a:lnSpc>
                <a:spcPts val="9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-phenylalanine catabolic process</a:t>
            </a:r>
          </a:p>
          <a:p>
            <a:pPr algn="r">
              <a:lnSpc>
                <a:spcPts val="9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sphatidylcholine biosynthetic process</a:t>
            </a:r>
          </a:p>
          <a:p>
            <a:pPr algn="r">
              <a:lnSpc>
                <a:spcPts val="900"/>
              </a:lnSpc>
            </a:pP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P9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gnalosome assembly</a:t>
            </a:r>
          </a:p>
          <a:p>
            <a:pPr algn="r">
              <a:lnSpc>
                <a:spcPts val="9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pid transport</a:t>
            </a:r>
          </a:p>
          <a:p>
            <a:pPr algn="r">
              <a:lnSpc>
                <a:spcPts val="9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ular catabolic process</a:t>
            </a:r>
          </a:p>
          <a:p>
            <a:pPr algn="r">
              <a:lnSpc>
                <a:spcPts val="9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ganonitrogen compound catabolic process</a:t>
            </a:r>
          </a:p>
          <a:p>
            <a:pPr algn="r">
              <a:lnSpc>
                <a:spcPts val="9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enzyme A biosynthetic process</a:t>
            </a:r>
          </a:p>
          <a:p>
            <a:pPr algn="r">
              <a:lnSpc>
                <a:spcPts val="9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yrosine metabolic process</a:t>
            </a:r>
          </a:p>
          <a:p>
            <a:pPr algn="r">
              <a:lnSpc>
                <a:spcPts val="9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A catabolic process</a:t>
            </a:r>
          </a:p>
          <a:p>
            <a:pPr algn="r">
              <a:lnSpc>
                <a:spcPts val="9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totropism</a:t>
            </a:r>
          </a:p>
          <a:p>
            <a:pPr algn="r">
              <a:lnSpc>
                <a:spcPts val="9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P-dependent chromatin remodeling</a:t>
            </a:r>
          </a:p>
          <a:p>
            <a:pPr algn="r">
              <a:lnSpc>
                <a:spcPts val="900"/>
              </a:lnSpc>
            </a:pP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llin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eddylation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ts val="9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dephosphorylation</a:t>
            </a:r>
          </a:p>
          <a:p>
            <a:pPr algn="r">
              <a:lnSpc>
                <a:spcPts val="9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ular component organization or biogenesis</a:t>
            </a:r>
          </a:p>
          <a:p>
            <a:pPr algn="r">
              <a:lnSpc>
                <a:spcPts val="9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nt-type cell wall organization</a:t>
            </a:r>
          </a:p>
          <a:p>
            <a:pPr algn="r">
              <a:lnSpc>
                <a:spcPts val="9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cognition of pollen</a:t>
            </a:r>
          </a:p>
          <a:p>
            <a:pPr algn="r">
              <a:lnSpc>
                <a:spcPts val="9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import into nucleus</a:t>
            </a:r>
          </a:p>
          <a:p>
            <a:pPr algn="r">
              <a:lnSpc>
                <a:spcPts val="9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itive regulation of superoxide dismutase activity</a:t>
            </a:r>
          </a:p>
          <a:p>
            <a:pPr algn="r">
              <a:lnSpc>
                <a:spcPts val="900"/>
              </a:lnSpc>
            </a:pP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P9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gnalosome</a:t>
            </a:r>
          </a:p>
          <a:p>
            <a:pPr algn="r">
              <a:lnSpc>
                <a:spcPts val="9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cromolecular complex binding</a:t>
            </a:r>
          </a:p>
          <a:p>
            <a:pPr algn="r">
              <a:lnSpc>
                <a:spcPts val="9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omatin binding</a:t>
            </a:r>
          </a:p>
          <a:p>
            <a:pPr algn="r">
              <a:lnSpc>
                <a:spcPts val="9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donuclease activity</a:t>
            </a:r>
          </a:p>
          <a:p>
            <a:pPr algn="r">
              <a:lnSpc>
                <a:spcPts val="9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ydrolase activity, acting on ester bonds</a:t>
            </a:r>
          </a:p>
          <a:p>
            <a:pPr algn="r">
              <a:lnSpc>
                <a:spcPts val="9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ycolipid transporter activity</a:t>
            </a:r>
          </a:p>
          <a:p>
            <a:pPr algn="r">
              <a:lnSpc>
                <a:spcPts val="9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ycolipid binding</a:t>
            </a:r>
          </a:p>
          <a:p>
            <a:pPr algn="r">
              <a:lnSpc>
                <a:spcPts val="900"/>
              </a:lnSpc>
            </a:pP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phospho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oA kinase activity</a:t>
            </a:r>
          </a:p>
          <a:p>
            <a:pPr algn="r">
              <a:lnSpc>
                <a:spcPts val="9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aminoacyl-tRNA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acylase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tivity</a:t>
            </a:r>
          </a:p>
          <a:p>
            <a:pPr algn="r">
              <a:lnSpc>
                <a:spcPts val="900"/>
              </a:lnSpc>
            </a:pP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omogentisate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,2-dioxygenase activity</a:t>
            </a:r>
          </a:p>
          <a:p>
            <a:pPr algn="r">
              <a:lnSpc>
                <a:spcPts val="900"/>
              </a:lnSpc>
            </a:pP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osphoethanolamine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-methyltransferase activity</a:t>
            </a:r>
          </a:p>
          <a:p>
            <a:pPr algn="r">
              <a:lnSpc>
                <a:spcPts val="9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lfate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denylyltransferase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TP) activity</a:t>
            </a:r>
          </a:p>
          <a:p>
            <a:pPr algn="r">
              <a:lnSpc>
                <a:spcPts val="9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bonuclease III activity</a:t>
            </a:r>
          </a:p>
          <a:p>
            <a:pPr algn="r">
              <a:lnSpc>
                <a:spcPts val="9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sphoprotein phosphatase activity</a:t>
            </a:r>
          </a:p>
          <a:p>
            <a:pPr algn="r">
              <a:lnSpc>
                <a:spcPts val="900"/>
              </a:lnSpc>
            </a:pP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stidinol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hydrogenase activity</a:t>
            </a:r>
          </a:p>
          <a:p>
            <a:pPr algn="r">
              <a:lnSpc>
                <a:spcPts val="900"/>
              </a:lnSpc>
            </a:pP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astoquinol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-plastocyanin reductase activity</a:t>
            </a:r>
          </a:p>
        </p:txBody>
      </p:sp>
      <p:sp>
        <p:nvSpPr>
          <p:cNvPr id="19" name="文本框 83">
            <a:extLst>
              <a:ext uri="{FF2B5EF4-FFF2-40B4-BE49-F238E27FC236}">
                <a16:creationId xmlns:a16="http://schemas.microsoft.com/office/drawing/2014/main" xmlns="" id="{ED1982D8-5518-47FA-BA54-A73D4DECC4C7}"/>
              </a:ext>
            </a:extLst>
          </p:cNvPr>
          <p:cNvSpPr txBox="1"/>
          <p:nvPr/>
        </p:nvSpPr>
        <p:spPr>
          <a:xfrm>
            <a:off x="7750865" y="286138"/>
            <a:ext cx="19078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 of Proteins (%)</a:t>
            </a:r>
          </a:p>
        </p:txBody>
      </p:sp>
      <p:sp>
        <p:nvSpPr>
          <p:cNvPr id="20" name="文本框 84">
            <a:extLst>
              <a:ext uri="{FF2B5EF4-FFF2-40B4-BE49-F238E27FC236}">
                <a16:creationId xmlns:a16="http://schemas.microsoft.com/office/drawing/2014/main" xmlns="" id="{4873A55D-5E2C-4721-B1E3-ACAEAC88C459}"/>
              </a:ext>
            </a:extLst>
          </p:cNvPr>
          <p:cNvSpPr txBox="1"/>
          <p:nvPr/>
        </p:nvSpPr>
        <p:spPr>
          <a:xfrm>
            <a:off x="7620000" y="505465"/>
            <a:ext cx="2209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                                             10</a:t>
            </a:r>
          </a:p>
        </p:txBody>
      </p:sp>
      <p:sp>
        <p:nvSpPr>
          <p:cNvPr id="21" name="文本框 85">
            <a:extLst>
              <a:ext uri="{FF2B5EF4-FFF2-40B4-BE49-F238E27FC236}">
                <a16:creationId xmlns:a16="http://schemas.microsoft.com/office/drawing/2014/main" xmlns="" id="{C4132476-38B4-403C-AE7B-A0F2ACFD97B9}"/>
              </a:ext>
            </a:extLst>
          </p:cNvPr>
          <p:cNvSpPr txBox="1"/>
          <p:nvPr/>
        </p:nvSpPr>
        <p:spPr>
          <a:xfrm>
            <a:off x="7623110" y="5181600"/>
            <a:ext cx="21644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                                            6.5</a:t>
            </a:r>
          </a:p>
        </p:txBody>
      </p:sp>
      <p:sp>
        <p:nvSpPr>
          <p:cNvPr id="22" name="文本框 86">
            <a:extLst>
              <a:ext uri="{FF2B5EF4-FFF2-40B4-BE49-F238E27FC236}">
                <a16:creationId xmlns:a16="http://schemas.microsoft.com/office/drawing/2014/main" xmlns="" id="{FA74417F-C024-4811-A049-07EC6363F12C}"/>
              </a:ext>
            </a:extLst>
          </p:cNvPr>
          <p:cNvSpPr txBox="1"/>
          <p:nvPr/>
        </p:nvSpPr>
        <p:spPr>
          <a:xfrm>
            <a:off x="7897008" y="5318831"/>
            <a:ext cx="16155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proteins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4904752" y="293591"/>
            <a:ext cx="4399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(B)</a:t>
            </a:r>
          </a:p>
        </p:txBody>
      </p:sp>
      <p:sp>
        <p:nvSpPr>
          <p:cNvPr id="18" name="右中括号 17"/>
          <p:cNvSpPr/>
          <p:nvPr/>
        </p:nvSpPr>
        <p:spPr>
          <a:xfrm>
            <a:off x="9287044" y="903516"/>
            <a:ext cx="108976" cy="2287651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右中括号 22"/>
          <p:cNvSpPr/>
          <p:nvPr/>
        </p:nvSpPr>
        <p:spPr>
          <a:xfrm>
            <a:off x="9290770" y="3217358"/>
            <a:ext cx="105465" cy="126627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右中括号 24"/>
          <p:cNvSpPr/>
          <p:nvPr/>
        </p:nvSpPr>
        <p:spPr>
          <a:xfrm>
            <a:off x="9290769" y="3375450"/>
            <a:ext cx="105223" cy="1653749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TextBox 25"/>
          <p:cNvSpPr txBox="1"/>
          <p:nvPr/>
        </p:nvSpPr>
        <p:spPr>
          <a:xfrm>
            <a:off x="9401762" y="1798298"/>
            <a:ext cx="4571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BP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9400593" y="3142171"/>
            <a:ext cx="4571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CC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9401762" y="4089931"/>
            <a:ext cx="4571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MF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" name="右中括号 29"/>
          <p:cNvSpPr/>
          <p:nvPr/>
        </p:nvSpPr>
        <p:spPr>
          <a:xfrm>
            <a:off x="4058430" y="866193"/>
            <a:ext cx="115691" cy="734007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1" name="右中括号 30"/>
          <p:cNvSpPr/>
          <p:nvPr/>
        </p:nvSpPr>
        <p:spPr>
          <a:xfrm>
            <a:off x="4058431" y="1649305"/>
            <a:ext cx="105464" cy="126627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" name="右中括号 31"/>
          <p:cNvSpPr/>
          <p:nvPr/>
        </p:nvSpPr>
        <p:spPr>
          <a:xfrm>
            <a:off x="4058430" y="1821626"/>
            <a:ext cx="106360" cy="1025767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TextBox 32"/>
          <p:cNvSpPr txBox="1"/>
          <p:nvPr/>
        </p:nvSpPr>
        <p:spPr>
          <a:xfrm>
            <a:off x="4170115" y="1094696"/>
            <a:ext cx="4571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BP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4167545" y="1574482"/>
            <a:ext cx="4571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CC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159639" y="2168016"/>
            <a:ext cx="4571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MF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152400" y="5782270"/>
            <a:ext cx="9506337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Figure S4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Gene ontology (GO) classification of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upregulated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(A) and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downregulated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(B) differentially expressed proteins (DEPs) identified in sugarcane cultivar ROC20 inoculated with </a:t>
            </a:r>
            <a:r>
              <a:rPr lang="en-US" altLang="zh-CN" sz="1200" i="1" dirty="0" err="1">
                <a:latin typeface="Times New Roman" pitchFamily="18" charset="0"/>
                <a:cs typeface="Times New Roman" pitchFamily="18" charset="0"/>
              </a:rPr>
              <a:t>Xanthomonas</a:t>
            </a:r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i="1" dirty="0" err="1">
                <a:latin typeface="Times New Roman" pitchFamily="18" charset="0"/>
                <a:cs typeface="Times New Roman" pitchFamily="18" charset="0"/>
              </a:rPr>
              <a:t>albilineans</a:t>
            </a:r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.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ROC20 is susceptible to leaf scald and data were determined 48 h post inoculation (S48_Xa vs. S0_CK). DEGs were distributed in three categories: biological process (BP), cellular component (CC), and molecular function MF). </a:t>
            </a:r>
            <a:endParaRPr lang="zh-CN" altLang="zh-CN" sz="12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93605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9</TotalTime>
  <Words>270</Words>
  <Application>Microsoft Office PowerPoint</Application>
  <PresentationFormat>A4 纸张(210x297 毫米)</PresentationFormat>
  <Paragraphs>66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Theme</vt:lpstr>
      <vt:lpstr>PowerPoint 演示文稿</vt:lpstr>
    </vt:vector>
  </TitlesOfParts>
  <Company>P R 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tambo</dc:creator>
  <cp:lastModifiedBy>GSJ</cp:lastModifiedBy>
  <cp:revision>12</cp:revision>
  <dcterms:created xsi:type="dcterms:W3CDTF">2019-06-20T06:19:23Z</dcterms:created>
  <dcterms:modified xsi:type="dcterms:W3CDTF">2019-11-05T14:31:55Z</dcterms:modified>
</cp:coreProperties>
</file>